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A58590-2BD8-4F1B-B2A0-FCB3CD8F5DE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3A8391-DD4C-4CAA-B298-E267A9A136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D743AF-2ABC-4FE3-9AED-7EA347F3BF4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DF5219-7804-413B-8370-A95C6D5FC54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573EC2-3F1D-4109-9CF1-24A9008BA0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AFD170-9C8C-4846-802D-0B44D887BF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126CA8-EDEB-444D-870C-06EA026A5A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B6D218-9803-42B9-B645-0C8EA04DFE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ADE40A-BF20-4DB6-B01C-B9A7271BF7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7B4FDC-38A4-4763-8AA7-5BC38DC5B9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193264-ACD4-4386-A371-E04A27A101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93FC9B-5C75-49CF-968D-9A67B665E1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C73CCA-E8BB-4C2B-8F71-5A0AD1CDCE1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362320" y="1447920"/>
          <a:ext cx="4343400" cy="1676160"/>
        </p:xfrm>
        <a:graphic>
          <a:graphicData uri="http://schemas.openxmlformats.org/drawingml/2006/table">
            <a:tbl>
              <a:tblPr/>
              <a:tblGrid>
                <a:gridCol w="2209680"/>
                <a:gridCol w="2133720"/>
              </a:tblGrid>
              <a:tr h="3808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ld of OPG expressio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o. of tumor section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088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-2 fol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 out of 3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720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-4 fol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 out of 3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720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-6 fol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 out of 3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3"/>
          <p:cNvSpPr/>
          <p:nvPr/>
        </p:nvSpPr>
        <p:spPr>
          <a:xfrm>
            <a:off x="0" y="0"/>
            <a:ext cx="2590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2-02T20:31:34Z</dcterms:created>
  <dc:creator>sudeshna.goswami</dc:creator>
  <dc:description/>
  <dc:language>en-US</dc:language>
  <cp:lastModifiedBy>sudeshna.goswami</cp:lastModifiedBy>
  <dcterms:modified xsi:type="dcterms:W3CDTF">2014-12-02T20:33:02Z</dcterms:modified>
  <cp:revision>3</cp:revision>
  <dc:subject/>
  <dc:title>Slide 1</dc:title>
</cp:coreProperties>
</file>